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9906000" cy="6858000" type="A4"/>
  <p:notesSz cx="6805613" cy="9944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 showGuides="1">
      <p:cViewPr>
        <p:scale>
          <a:sx n="111" d="100"/>
          <a:sy n="111" d="100"/>
        </p:scale>
        <p:origin x="-1327" y="-1649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89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89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759651-1826-4847-9FF4-EDC484D1094D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79488" y="1243013"/>
            <a:ext cx="484663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85598"/>
            <a:ext cx="5444490" cy="3915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70"/>
            <a:ext cx="2949099" cy="49893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70"/>
            <a:ext cx="2949099" cy="49893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916E7A-8280-40CD-B0D4-548D8B4CFE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9511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79488" y="1243013"/>
            <a:ext cx="4846637" cy="33559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TV1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ameter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quired Dose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GB" sz="1200" b="0" i="0" u="none" strike="noStrike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98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90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7.6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TV64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GB" sz="1200" b="0" i="0" u="none" strike="noStrike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95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95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0.8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GB" sz="1200" b="0" i="0" u="none" strike="noStrike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0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00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4.0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lect Structure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GB" sz="1200" b="0" i="0" u="none" strike="noStrike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05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7.2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GB" sz="1200" b="0" i="0" u="none" strike="noStrike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07%</a:t>
            </a:r>
            <a:r>
              <a:rPr lang="en-GB" dirty="0" smtClean="0"/>
              <a:t> </a:t>
            </a:r>
            <a:r>
              <a:rPr lang="en-GB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8.5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EA3C23-2C6F-4219-B693-34467EEE2D5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6934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897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1894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5877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181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179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215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389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9954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5597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3882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2174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05A6C-9057-4FE9-94C5-423E8D08C0DE}" type="datetimeFigureOut">
              <a:rPr lang="en-GB" smtClean="0"/>
              <a:t>21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444C2-01DA-4AF0-B924-EA746DF4138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944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2036839" y="4291549"/>
            <a:ext cx="6816875" cy="52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35609" tIns="17805" rIns="35609" bIns="17805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356085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8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2. Changes in </a:t>
            </a:r>
            <a:r>
              <a:rPr lang="en-GB" altLang="en-US" sz="8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centre- of- </a:t>
            </a:r>
            <a:r>
              <a:rPr lang="en-GB" altLang="en-US" sz="8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mass of the </a:t>
            </a:r>
            <a:r>
              <a:rPr lang="en-GB" altLang="en-US" sz="8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clinical target volume (CTV) and organs- at-risk (OARs) for </a:t>
            </a:r>
            <a:r>
              <a:rPr lang="en-GB" altLang="en-US" sz="8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case 2. </a:t>
            </a:r>
            <a:r>
              <a:rPr lang="en-GB" altLang="en-US" sz="8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Within the resolution limits of the planning CT, minimal change in the </a:t>
            </a:r>
            <a:r>
              <a:rPr lang="en-GB" altLang="en-US" sz="8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centre- of- </a:t>
            </a:r>
            <a:r>
              <a:rPr lang="en-GB" altLang="en-US" sz="8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mass position is demonstrated at the extremes of breathing relative to their position as seen on the CT Ave. </a:t>
            </a:r>
            <a:r>
              <a:rPr lang="en-GB" altLang="en-US" sz="8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8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In particular, there is </a:t>
            </a:r>
            <a:r>
              <a:rPr lang="en-GB" altLang="en-US" sz="8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&lt;2mm </a:t>
            </a:r>
            <a:r>
              <a:rPr lang="en-GB" altLang="en-US" sz="8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change in the centre-of-mass position of the brachial </a:t>
            </a:r>
            <a:r>
              <a:rPr lang="en-GB" altLang="en-US" sz="8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plexus. </a:t>
            </a:r>
            <a:r>
              <a:rPr lang="en-GB" altLang="en-US" sz="8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he maximal change in position at the extremes of breathing was seen in lungs and heart.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4215142"/>
              </p:ext>
            </p:extLst>
          </p:nvPr>
        </p:nvGraphicFramePr>
        <p:xfrm>
          <a:off x="2036839" y="2399697"/>
          <a:ext cx="6816875" cy="180548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1953"/>
                <a:gridCol w="847878"/>
                <a:gridCol w="619977"/>
                <a:gridCol w="676915"/>
                <a:gridCol w="492794"/>
                <a:gridCol w="702437"/>
                <a:gridCol w="726868"/>
                <a:gridCol w="726868"/>
                <a:gridCol w="726868"/>
                <a:gridCol w="504317"/>
              </a:tblGrid>
              <a:tr h="252533">
                <a:tc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</a:rPr>
                        <a:t>CTAve-CT0 Change in </a:t>
                      </a:r>
                      <a:r>
                        <a:rPr lang="en-GB" sz="800" b="1" u="none" strike="noStrike" dirty="0" smtClean="0">
                          <a:effectLst/>
                        </a:rPr>
                        <a:t>Centre- of- </a:t>
                      </a:r>
                      <a:r>
                        <a:rPr lang="en-GB" sz="800" b="1" u="none" strike="noStrike" dirty="0">
                          <a:effectLst/>
                        </a:rPr>
                        <a:t>Mas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</a:rPr>
                        <a:t>CTAve-CT50 Change in </a:t>
                      </a:r>
                      <a:r>
                        <a:rPr lang="en-GB" sz="800" b="1" u="none" strike="noStrike" dirty="0" smtClean="0">
                          <a:effectLst/>
                        </a:rPr>
                        <a:t>Centre- of- </a:t>
                      </a:r>
                      <a:r>
                        <a:rPr lang="en-GB" sz="800" b="1" u="none" strike="noStrike" dirty="0">
                          <a:effectLst/>
                        </a:rPr>
                        <a:t>Mas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0- CT50 Change in Centre- of- Mas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8" marR="2638" marT="263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00" marR="3800" marT="380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00" marR="3800" marT="380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533">
                <a:tc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</a:rPr>
                        <a:t>x axis (cm)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</a:rPr>
                        <a:t>y axis  (cm)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>
                          <a:effectLst/>
                        </a:rPr>
                        <a:t>z axis  (cm)</a:t>
                      </a:r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</a:rPr>
                        <a:t>x axis (cm)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</a:rPr>
                        <a:t>y axis  (cm)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</a:rPr>
                        <a:t>z axis  (cm)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 axis (cm)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 axis  (cm)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 axis  (cm)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3583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CTV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0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0.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-0.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0.0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6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3583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Ipsilateral Lung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0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2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1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5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700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Contralateral Lung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-0.0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1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0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1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</a:t>
                      </a:r>
                      <a:r>
                        <a:rPr lang="en-GB" sz="800" u="none" strike="noStrike" dirty="0" smtClean="0">
                          <a:effectLst/>
                        </a:rPr>
                        <a:t>1.6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4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3583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Heart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-0.2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1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0.1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1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-0.3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8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3583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Oesophagu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-0.0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1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0.1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3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2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3583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Spinal Canal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3583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Brachial plexu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0.0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0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0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1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0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0.0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2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</a:t>
                      </a: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2700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</a:rPr>
                        <a:t>Thoracic vertebra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-0.0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1" marR="2631" marT="263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38" marR="2638" marT="263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24291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5</TotalTime>
  <Words>288</Words>
  <Application>Microsoft Office PowerPoint</Application>
  <PresentationFormat>A4 Paper (210x297 mm)</PresentationFormat>
  <Paragraphs>9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wee-Ling Wong</dc:creator>
  <cp:lastModifiedBy>Swee-Ling Wong</cp:lastModifiedBy>
  <cp:revision>22</cp:revision>
  <cp:lastPrinted>2020-02-27T09:03:29Z</cp:lastPrinted>
  <dcterms:created xsi:type="dcterms:W3CDTF">2020-02-04T16:28:25Z</dcterms:created>
  <dcterms:modified xsi:type="dcterms:W3CDTF">2020-05-21T20:08:20Z</dcterms:modified>
</cp:coreProperties>
</file>